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9263" autoAdjust="0"/>
  </p:normalViewPr>
  <p:slideViewPr>
    <p:cSldViewPr>
      <p:cViewPr>
        <p:scale>
          <a:sx n="71" d="100"/>
          <a:sy n="71" d="100"/>
        </p:scale>
        <p:origin x="-135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FA9DB-EDFA-4EE9-8739-267294C3688F}" type="datetimeFigureOut">
              <a:rPr lang="zh-CN" altLang="en-US" smtClean="0"/>
              <a:t>2017/1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50EE8-B5DD-4837-B9FF-B1E76C236E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5309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FA9DB-EDFA-4EE9-8739-267294C3688F}" type="datetimeFigureOut">
              <a:rPr lang="zh-CN" altLang="en-US" smtClean="0"/>
              <a:t>2017/1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50EE8-B5DD-4837-B9FF-B1E76C236E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1950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FA9DB-EDFA-4EE9-8739-267294C3688F}" type="datetimeFigureOut">
              <a:rPr lang="zh-CN" altLang="en-US" smtClean="0"/>
              <a:t>2017/1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50EE8-B5DD-4837-B9FF-B1E76C236E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576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FA9DB-EDFA-4EE9-8739-267294C3688F}" type="datetimeFigureOut">
              <a:rPr lang="zh-CN" altLang="en-US" smtClean="0"/>
              <a:t>2017/1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50EE8-B5DD-4837-B9FF-B1E76C236E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13673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FA9DB-EDFA-4EE9-8739-267294C3688F}" type="datetimeFigureOut">
              <a:rPr lang="zh-CN" altLang="en-US" smtClean="0"/>
              <a:t>2017/1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50EE8-B5DD-4837-B9FF-B1E76C236E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610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FA9DB-EDFA-4EE9-8739-267294C3688F}" type="datetimeFigureOut">
              <a:rPr lang="zh-CN" altLang="en-US" smtClean="0"/>
              <a:t>2017/11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50EE8-B5DD-4837-B9FF-B1E76C236E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7779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FA9DB-EDFA-4EE9-8739-267294C3688F}" type="datetimeFigureOut">
              <a:rPr lang="zh-CN" altLang="en-US" smtClean="0"/>
              <a:t>2017/11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50EE8-B5DD-4837-B9FF-B1E76C236E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1616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FA9DB-EDFA-4EE9-8739-267294C3688F}" type="datetimeFigureOut">
              <a:rPr lang="zh-CN" altLang="en-US" smtClean="0"/>
              <a:t>2017/11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50EE8-B5DD-4837-B9FF-B1E76C236E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218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FA9DB-EDFA-4EE9-8739-267294C3688F}" type="datetimeFigureOut">
              <a:rPr lang="zh-CN" altLang="en-US" smtClean="0"/>
              <a:t>2017/11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50EE8-B5DD-4837-B9FF-B1E76C236E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9195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FA9DB-EDFA-4EE9-8739-267294C3688F}" type="datetimeFigureOut">
              <a:rPr lang="zh-CN" altLang="en-US" smtClean="0"/>
              <a:t>2017/11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50EE8-B5DD-4837-B9FF-B1E76C236E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74162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FA9DB-EDFA-4EE9-8739-267294C3688F}" type="datetimeFigureOut">
              <a:rPr lang="zh-CN" altLang="en-US" smtClean="0"/>
              <a:t>2017/11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50EE8-B5DD-4837-B9FF-B1E76C236E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31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6FA9DB-EDFA-4EE9-8739-267294C3688F}" type="datetimeFigureOut">
              <a:rPr lang="zh-CN" altLang="en-US" smtClean="0"/>
              <a:t>2017/11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C50EE8-B5DD-4837-B9FF-B1E76C236E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9796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9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爆炸形 1 4"/>
          <p:cNvSpPr/>
          <p:nvPr/>
        </p:nvSpPr>
        <p:spPr>
          <a:xfrm>
            <a:off x="2940406" y="44624"/>
            <a:ext cx="2304256" cy="914400"/>
          </a:xfrm>
          <a:prstGeom prst="irregularSeal1">
            <a:avLst/>
          </a:prstGeom>
          <a:noFill/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TextBox 5"/>
          <p:cNvSpPr txBox="1"/>
          <p:nvPr/>
        </p:nvSpPr>
        <p:spPr>
          <a:xfrm>
            <a:off x="3403948" y="317158"/>
            <a:ext cx="13944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compression</a:t>
            </a:r>
            <a:endParaRPr lang="zh-CN" altLang="en-US" b="1" dirty="0"/>
          </a:p>
        </p:txBody>
      </p:sp>
      <p:cxnSp>
        <p:nvCxnSpPr>
          <p:cNvPr id="10" name="直接连接符 9"/>
          <p:cNvCxnSpPr/>
          <p:nvPr/>
        </p:nvCxnSpPr>
        <p:spPr>
          <a:xfrm>
            <a:off x="216421" y="1647458"/>
            <a:ext cx="36004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>
            <a:off x="4296147" y="1643848"/>
            <a:ext cx="22281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" name="椭圆 20"/>
          <p:cNvSpPr/>
          <p:nvPr/>
        </p:nvSpPr>
        <p:spPr>
          <a:xfrm>
            <a:off x="2214156" y="2510164"/>
            <a:ext cx="3437644" cy="147543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任意多边形 22"/>
          <p:cNvSpPr/>
          <p:nvPr/>
        </p:nvSpPr>
        <p:spPr>
          <a:xfrm>
            <a:off x="2706808" y="2767637"/>
            <a:ext cx="2517970" cy="960491"/>
          </a:xfrm>
          <a:custGeom>
            <a:avLst/>
            <a:gdLst>
              <a:gd name="connsiteX0" fmla="*/ 216569 w 1577342"/>
              <a:gd name="connsiteY0" fmla="*/ 192698 h 481473"/>
              <a:gd name="connsiteX1" fmla="*/ 360948 w 1577342"/>
              <a:gd name="connsiteY1" fmla="*/ 60351 h 481473"/>
              <a:gd name="connsiteX2" fmla="*/ 481264 w 1577342"/>
              <a:gd name="connsiteY2" fmla="*/ 168635 h 481473"/>
              <a:gd name="connsiteX3" fmla="*/ 661737 w 1577342"/>
              <a:gd name="connsiteY3" fmla="*/ 12225 h 481473"/>
              <a:gd name="connsiteX4" fmla="*/ 818148 w 1577342"/>
              <a:gd name="connsiteY4" fmla="*/ 132540 h 481473"/>
              <a:gd name="connsiteX5" fmla="*/ 1022685 w 1577342"/>
              <a:gd name="connsiteY5" fmla="*/ 193 h 481473"/>
              <a:gd name="connsiteX6" fmla="*/ 1155032 w 1577342"/>
              <a:gd name="connsiteY6" fmla="*/ 168635 h 481473"/>
              <a:gd name="connsiteX7" fmla="*/ 1359569 w 1577342"/>
              <a:gd name="connsiteY7" fmla="*/ 108477 h 481473"/>
              <a:gd name="connsiteX8" fmla="*/ 1576137 w 1577342"/>
              <a:gd name="connsiteY8" fmla="*/ 264888 h 481473"/>
              <a:gd name="connsiteX9" fmla="*/ 1431758 w 1577342"/>
              <a:gd name="connsiteY9" fmla="*/ 361140 h 481473"/>
              <a:gd name="connsiteX10" fmla="*/ 1118937 w 1577342"/>
              <a:gd name="connsiteY10" fmla="*/ 288951 h 481473"/>
              <a:gd name="connsiteX11" fmla="*/ 1010653 w 1577342"/>
              <a:gd name="connsiteY11" fmla="*/ 481456 h 481473"/>
              <a:gd name="connsiteX12" fmla="*/ 818148 w 1577342"/>
              <a:gd name="connsiteY12" fmla="*/ 276919 h 481473"/>
              <a:gd name="connsiteX13" fmla="*/ 625643 w 1577342"/>
              <a:gd name="connsiteY13" fmla="*/ 433330 h 481473"/>
              <a:gd name="connsiteX14" fmla="*/ 481264 w 1577342"/>
              <a:gd name="connsiteY14" fmla="*/ 288951 h 481473"/>
              <a:gd name="connsiteX15" fmla="*/ 168443 w 1577342"/>
              <a:gd name="connsiteY15" fmla="*/ 433330 h 481473"/>
              <a:gd name="connsiteX16" fmla="*/ 0 w 1577342"/>
              <a:gd name="connsiteY16" fmla="*/ 240825 h 481473"/>
              <a:gd name="connsiteX17" fmla="*/ 168443 w 1577342"/>
              <a:gd name="connsiteY17" fmla="*/ 156604 h 481473"/>
              <a:gd name="connsiteX18" fmla="*/ 216569 w 1577342"/>
              <a:gd name="connsiteY18" fmla="*/ 192698 h 48147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</a:cxnLst>
            <a:rect l="l" t="t" r="r" b="b"/>
            <a:pathLst>
              <a:path w="1577342" h="481473">
                <a:moveTo>
                  <a:pt x="216569" y="192698"/>
                </a:moveTo>
                <a:cubicBezTo>
                  <a:pt x="248653" y="176656"/>
                  <a:pt x="316832" y="64361"/>
                  <a:pt x="360948" y="60351"/>
                </a:cubicBezTo>
                <a:cubicBezTo>
                  <a:pt x="405064" y="56340"/>
                  <a:pt x="431133" y="176656"/>
                  <a:pt x="481264" y="168635"/>
                </a:cubicBezTo>
                <a:cubicBezTo>
                  <a:pt x="531395" y="160614"/>
                  <a:pt x="605590" y="18241"/>
                  <a:pt x="661737" y="12225"/>
                </a:cubicBezTo>
                <a:cubicBezTo>
                  <a:pt x="717884" y="6209"/>
                  <a:pt x="757990" y="134545"/>
                  <a:pt x="818148" y="132540"/>
                </a:cubicBezTo>
                <a:cubicBezTo>
                  <a:pt x="878306" y="130535"/>
                  <a:pt x="966538" y="-5823"/>
                  <a:pt x="1022685" y="193"/>
                </a:cubicBezTo>
                <a:cubicBezTo>
                  <a:pt x="1078832" y="6209"/>
                  <a:pt x="1098885" y="150588"/>
                  <a:pt x="1155032" y="168635"/>
                </a:cubicBezTo>
                <a:cubicBezTo>
                  <a:pt x="1211179" y="186682"/>
                  <a:pt x="1289385" y="92435"/>
                  <a:pt x="1359569" y="108477"/>
                </a:cubicBezTo>
                <a:cubicBezTo>
                  <a:pt x="1429753" y="124519"/>
                  <a:pt x="1564106" y="222778"/>
                  <a:pt x="1576137" y="264888"/>
                </a:cubicBezTo>
                <a:cubicBezTo>
                  <a:pt x="1588169" y="306999"/>
                  <a:pt x="1507958" y="357130"/>
                  <a:pt x="1431758" y="361140"/>
                </a:cubicBezTo>
                <a:cubicBezTo>
                  <a:pt x="1355558" y="365150"/>
                  <a:pt x="1189121" y="268898"/>
                  <a:pt x="1118937" y="288951"/>
                </a:cubicBezTo>
                <a:cubicBezTo>
                  <a:pt x="1048753" y="309004"/>
                  <a:pt x="1060784" y="483461"/>
                  <a:pt x="1010653" y="481456"/>
                </a:cubicBezTo>
                <a:cubicBezTo>
                  <a:pt x="960522" y="479451"/>
                  <a:pt x="882316" y="284940"/>
                  <a:pt x="818148" y="276919"/>
                </a:cubicBezTo>
                <a:cubicBezTo>
                  <a:pt x="753980" y="268898"/>
                  <a:pt x="681790" y="431325"/>
                  <a:pt x="625643" y="433330"/>
                </a:cubicBezTo>
                <a:cubicBezTo>
                  <a:pt x="569496" y="435335"/>
                  <a:pt x="557464" y="288951"/>
                  <a:pt x="481264" y="288951"/>
                </a:cubicBezTo>
                <a:cubicBezTo>
                  <a:pt x="405064" y="288951"/>
                  <a:pt x="248654" y="441351"/>
                  <a:pt x="168443" y="433330"/>
                </a:cubicBezTo>
                <a:cubicBezTo>
                  <a:pt x="88232" y="425309"/>
                  <a:pt x="0" y="286946"/>
                  <a:pt x="0" y="240825"/>
                </a:cubicBezTo>
                <a:cubicBezTo>
                  <a:pt x="0" y="194704"/>
                  <a:pt x="128338" y="168636"/>
                  <a:pt x="168443" y="156604"/>
                </a:cubicBezTo>
                <a:cubicBezTo>
                  <a:pt x="208548" y="144572"/>
                  <a:pt x="184485" y="208740"/>
                  <a:pt x="216569" y="192698"/>
                </a:cubicBezTo>
                <a:close/>
              </a:path>
            </a:pathLst>
          </a:cu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减号 25"/>
          <p:cNvSpPr/>
          <p:nvPr/>
        </p:nvSpPr>
        <p:spPr>
          <a:xfrm rot="20016809">
            <a:off x="2286944" y="2675122"/>
            <a:ext cx="720080" cy="174575"/>
          </a:xfrm>
          <a:prstGeom prst="mathMinus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减号 26"/>
          <p:cNvSpPr/>
          <p:nvPr/>
        </p:nvSpPr>
        <p:spPr>
          <a:xfrm rot="19951541">
            <a:off x="4911526" y="3614936"/>
            <a:ext cx="720080" cy="174575"/>
          </a:xfrm>
          <a:prstGeom prst="mathMinus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减号 27"/>
          <p:cNvSpPr/>
          <p:nvPr/>
        </p:nvSpPr>
        <p:spPr>
          <a:xfrm rot="994660">
            <a:off x="2628471" y="3693320"/>
            <a:ext cx="415471" cy="223622"/>
          </a:xfrm>
          <a:prstGeom prst="mathMinus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减号 28"/>
          <p:cNvSpPr/>
          <p:nvPr/>
        </p:nvSpPr>
        <p:spPr>
          <a:xfrm rot="21287630">
            <a:off x="3926715" y="3884276"/>
            <a:ext cx="720080" cy="174575"/>
          </a:xfrm>
          <a:prstGeom prst="mathMinus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减号 29"/>
          <p:cNvSpPr/>
          <p:nvPr/>
        </p:nvSpPr>
        <p:spPr>
          <a:xfrm rot="382918">
            <a:off x="4172181" y="2461091"/>
            <a:ext cx="399819" cy="154077"/>
          </a:xfrm>
          <a:prstGeom prst="mathMinus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流程图: 合并 32"/>
          <p:cNvSpPr/>
          <p:nvPr/>
        </p:nvSpPr>
        <p:spPr>
          <a:xfrm>
            <a:off x="3294276" y="2348880"/>
            <a:ext cx="284066" cy="413529"/>
          </a:xfrm>
          <a:prstGeom prst="flowChartMerge">
            <a:avLst/>
          </a:prstGeom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流程图: 联系 33"/>
          <p:cNvSpPr/>
          <p:nvPr/>
        </p:nvSpPr>
        <p:spPr>
          <a:xfrm>
            <a:off x="3237126" y="3645073"/>
            <a:ext cx="114300" cy="1143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流程图: 联系 34"/>
          <p:cNvSpPr/>
          <p:nvPr/>
        </p:nvSpPr>
        <p:spPr>
          <a:xfrm>
            <a:off x="3356030" y="3805131"/>
            <a:ext cx="114300" cy="1143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流程图: 联系 35"/>
          <p:cNvSpPr/>
          <p:nvPr/>
        </p:nvSpPr>
        <p:spPr>
          <a:xfrm>
            <a:off x="3413180" y="3587923"/>
            <a:ext cx="114300" cy="1143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流程图: 联系 36"/>
          <p:cNvSpPr/>
          <p:nvPr/>
        </p:nvSpPr>
        <p:spPr>
          <a:xfrm>
            <a:off x="3487847" y="3763572"/>
            <a:ext cx="114300" cy="1143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9" name="直接箭头连接符 38"/>
          <p:cNvCxnSpPr/>
          <p:nvPr/>
        </p:nvCxnSpPr>
        <p:spPr>
          <a:xfrm flipH="1">
            <a:off x="3487847" y="3919431"/>
            <a:ext cx="1" cy="31892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1" name="流程图: 联系 40"/>
          <p:cNvSpPr/>
          <p:nvPr/>
        </p:nvSpPr>
        <p:spPr>
          <a:xfrm>
            <a:off x="3266129" y="4238356"/>
            <a:ext cx="114300" cy="1143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流程图: 联系 41"/>
          <p:cNvSpPr/>
          <p:nvPr/>
        </p:nvSpPr>
        <p:spPr>
          <a:xfrm>
            <a:off x="3241730" y="4391597"/>
            <a:ext cx="114300" cy="1143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" name="流程图: 联系 42"/>
          <p:cNvSpPr/>
          <p:nvPr/>
        </p:nvSpPr>
        <p:spPr>
          <a:xfrm>
            <a:off x="3413180" y="4352656"/>
            <a:ext cx="114300" cy="1143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" name="流程图: 联系 43"/>
          <p:cNvSpPr/>
          <p:nvPr/>
        </p:nvSpPr>
        <p:spPr>
          <a:xfrm>
            <a:off x="3475063" y="4548361"/>
            <a:ext cx="114300" cy="1143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6" name="TextBox 45"/>
          <p:cNvSpPr txBox="1"/>
          <p:nvPr/>
        </p:nvSpPr>
        <p:spPr>
          <a:xfrm>
            <a:off x="3941089" y="5061644"/>
            <a:ext cx="1476166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zh-CN" b="1" dirty="0" smtClean="0"/>
              <a:t>procaspase-9</a:t>
            </a:r>
            <a:endParaRPr lang="zh-CN" altLang="en-US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2286164" y="5579948"/>
            <a:ext cx="1872203" cy="3693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zh-CN" b="1" dirty="0" smtClean="0"/>
              <a:t>Active caspase-9</a:t>
            </a:r>
            <a:endParaRPr lang="zh-CN" altLang="en-US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1494076" y="6011996"/>
            <a:ext cx="1476166" cy="3693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zh-CN" b="1" dirty="0" smtClean="0"/>
              <a:t>procaspase-3</a:t>
            </a:r>
            <a:endParaRPr lang="zh-CN" altLang="en-US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3323279" y="6011996"/>
            <a:ext cx="1872203" cy="3693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zh-CN" b="1" dirty="0" smtClean="0"/>
              <a:t>Active caspase-3</a:t>
            </a:r>
            <a:endParaRPr lang="zh-CN" altLang="en-US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3989410" y="6444044"/>
            <a:ext cx="2037608" cy="3693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zh-CN" b="1" dirty="0" smtClean="0"/>
              <a:t>cleaved substrates</a:t>
            </a:r>
            <a:endParaRPr lang="zh-CN" altLang="en-US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2444327" y="6444044"/>
            <a:ext cx="1312071" cy="3693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zh-CN" b="1" dirty="0" smtClean="0"/>
              <a:t>substrates</a:t>
            </a:r>
            <a:endParaRPr lang="zh-CN" altLang="en-US" b="1" dirty="0"/>
          </a:p>
        </p:txBody>
      </p:sp>
      <p:sp>
        <p:nvSpPr>
          <p:cNvPr id="54" name="左大括号 53"/>
          <p:cNvSpPr/>
          <p:nvPr/>
        </p:nvSpPr>
        <p:spPr>
          <a:xfrm>
            <a:off x="2676709" y="4135446"/>
            <a:ext cx="391048" cy="1295530"/>
          </a:xfrm>
          <a:prstGeom prst="lef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5" name="TextBox 54"/>
          <p:cNvSpPr txBox="1"/>
          <p:nvPr/>
        </p:nvSpPr>
        <p:spPr>
          <a:xfrm>
            <a:off x="4005435" y="4134792"/>
            <a:ext cx="174515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cytochrome </a:t>
            </a:r>
            <a:r>
              <a:rPr lang="en-US" altLang="zh-CN" b="1" i="1" dirty="0" smtClean="0"/>
              <a:t>c</a:t>
            </a:r>
          </a:p>
          <a:p>
            <a:r>
              <a:rPr lang="en-US" altLang="zh-CN" b="1" dirty="0" smtClean="0"/>
              <a:t>     Apaf-1</a:t>
            </a:r>
          </a:p>
          <a:p>
            <a:r>
              <a:rPr lang="en-US" altLang="zh-CN" b="1" dirty="0" smtClean="0"/>
              <a:t>         ATP</a:t>
            </a:r>
            <a:endParaRPr lang="zh-CN" altLang="en-US" b="1" dirty="0"/>
          </a:p>
        </p:txBody>
      </p:sp>
      <p:sp>
        <p:nvSpPr>
          <p:cNvPr id="56" name="矩形 55"/>
          <p:cNvSpPr/>
          <p:nvPr/>
        </p:nvSpPr>
        <p:spPr>
          <a:xfrm>
            <a:off x="3569826" y="3602231"/>
            <a:ext cx="145264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cytochrome </a:t>
            </a:r>
            <a:r>
              <a:rPr lang="en-US" altLang="zh-CN" b="1" i="1" dirty="0" smtClean="0"/>
              <a:t>c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1286648" y="4596457"/>
            <a:ext cx="1412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 smtClean="0"/>
              <a:t>Apoptosome</a:t>
            </a:r>
            <a:endParaRPr lang="zh-CN" altLang="en-US" b="1" dirty="0"/>
          </a:p>
        </p:txBody>
      </p:sp>
      <p:sp>
        <p:nvSpPr>
          <p:cNvPr id="59" name="八角星 58"/>
          <p:cNvSpPr/>
          <p:nvPr/>
        </p:nvSpPr>
        <p:spPr>
          <a:xfrm>
            <a:off x="3756398" y="3971565"/>
            <a:ext cx="1914142" cy="1086557"/>
          </a:xfrm>
          <a:prstGeom prst="star8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60" name="直接箭头连接符 59"/>
          <p:cNvCxnSpPr/>
          <p:nvPr/>
        </p:nvCxnSpPr>
        <p:spPr>
          <a:xfrm flipH="1">
            <a:off x="3399605" y="5485477"/>
            <a:ext cx="438501" cy="188941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3" name="直接箭头连接符 62"/>
          <p:cNvCxnSpPr>
            <a:endCxn id="49" idx="1"/>
          </p:cNvCxnSpPr>
          <p:nvPr/>
        </p:nvCxnSpPr>
        <p:spPr>
          <a:xfrm>
            <a:off x="2872233" y="6196662"/>
            <a:ext cx="451046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0" name="直接箭头连接符 69"/>
          <p:cNvCxnSpPr/>
          <p:nvPr/>
        </p:nvCxnSpPr>
        <p:spPr>
          <a:xfrm>
            <a:off x="3563310" y="6657140"/>
            <a:ext cx="451046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2" name="直接箭头连接符 71"/>
          <p:cNvCxnSpPr/>
          <p:nvPr/>
        </p:nvCxnSpPr>
        <p:spPr>
          <a:xfrm>
            <a:off x="3070149" y="5877272"/>
            <a:ext cx="0" cy="22217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4" name="直接箭头连接符 73"/>
          <p:cNvCxnSpPr/>
          <p:nvPr/>
        </p:nvCxnSpPr>
        <p:spPr>
          <a:xfrm>
            <a:off x="3798332" y="6375174"/>
            <a:ext cx="0" cy="22217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5" name="直接箭头连接符 74"/>
          <p:cNvCxnSpPr/>
          <p:nvPr/>
        </p:nvCxnSpPr>
        <p:spPr>
          <a:xfrm>
            <a:off x="5940152" y="6650492"/>
            <a:ext cx="451046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6372200" y="6444044"/>
            <a:ext cx="1133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Apoptosis</a:t>
            </a:r>
            <a:endParaRPr lang="zh-CN" altLang="en-US" b="1" dirty="0"/>
          </a:p>
        </p:txBody>
      </p:sp>
      <p:cxnSp>
        <p:nvCxnSpPr>
          <p:cNvPr id="78" name="直接箭头连接符 77"/>
          <p:cNvCxnSpPr/>
          <p:nvPr/>
        </p:nvCxnSpPr>
        <p:spPr>
          <a:xfrm>
            <a:off x="4079666" y="977682"/>
            <a:ext cx="2254" cy="102981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5" name="TextBox 84"/>
          <p:cNvSpPr txBox="1"/>
          <p:nvPr/>
        </p:nvSpPr>
        <p:spPr>
          <a:xfrm>
            <a:off x="6692502" y="855370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BMSCs</a:t>
            </a:r>
            <a:endParaRPr lang="zh-CN" altLang="en-US" b="1" dirty="0"/>
          </a:p>
        </p:txBody>
      </p:sp>
      <p:sp>
        <p:nvSpPr>
          <p:cNvPr id="86" name="流程图: 决策 85"/>
          <p:cNvSpPr/>
          <p:nvPr/>
        </p:nvSpPr>
        <p:spPr>
          <a:xfrm>
            <a:off x="6372200" y="864736"/>
            <a:ext cx="1345950" cy="369332"/>
          </a:xfrm>
          <a:prstGeom prst="flowChartDecision">
            <a:avLst/>
          </a:prstGeom>
          <a:noFill/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7" name="TextBox 86"/>
          <p:cNvSpPr txBox="1"/>
          <p:nvPr/>
        </p:nvSpPr>
        <p:spPr>
          <a:xfrm>
            <a:off x="7340574" y="548680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BMSCs</a:t>
            </a:r>
            <a:endParaRPr lang="zh-CN" altLang="en-US" b="1" dirty="0"/>
          </a:p>
        </p:txBody>
      </p:sp>
      <p:sp>
        <p:nvSpPr>
          <p:cNvPr id="88" name="流程图: 决策 87"/>
          <p:cNvSpPr/>
          <p:nvPr/>
        </p:nvSpPr>
        <p:spPr>
          <a:xfrm>
            <a:off x="7020272" y="558046"/>
            <a:ext cx="1345950" cy="369332"/>
          </a:xfrm>
          <a:prstGeom prst="flowChartDecision">
            <a:avLst/>
          </a:prstGeom>
          <a:noFill/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1" name="TextBox 90"/>
          <p:cNvSpPr txBox="1"/>
          <p:nvPr/>
        </p:nvSpPr>
        <p:spPr>
          <a:xfrm>
            <a:off x="7412582" y="112474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BMSCs</a:t>
            </a:r>
            <a:endParaRPr lang="zh-CN" altLang="en-US" b="1" dirty="0"/>
          </a:p>
        </p:txBody>
      </p:sp>
      <p:sp>
        <p:nvSpPr>
          <p:cNvPr id="92" name="流程图: 决策 91"/>
          <p:cNvSpPr/>
          <p:nvPr/>
        </p:nvSpPr>
        <p:spPr>
          <a:xfrm>
            <a:off x="7092280" y="1134110"/>
            <a:ext cx="1345950" cy="369332"/>
          </a:xfrm>
          <a:prstGeom prst="flowChartDecision">
            <a:avLst/>
          </a:prstGeom>
          <a:noFill/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3" name="TextBox 92"/>
          <p:cNvSpPr txBox="1"/>
          <p:nvPr/>
        </p:nvSpPr>
        <p:spPr>
          <a:xfrm>
            <a:off x="8082856" y="836712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BMSCs</a:t>
            </a:r>
            <a:endParaRPr lang="zh-CN" altLang="en-US" b="1" dirty="0"/>
          </a:p>
        </p:txBody>
      </p:sp>
      <p:sp>
        <p:nvSpPr>
          <p:cNvPr id="94" name="流程图: 决策 93"/>
          <p:cNvSpPr/>
          <p:nvPr/>
        </p:nvSpPr>
        <p:spPr>
          <a:xfrm>
            <a:off x="7762554" y="846078"/>
            <a:ext cx="1345950" cy="369332"/>
          </a:xfrm>
          <a:prstGeom prst="flowChartDecision">
            <a:avLst/>
          </a:prstGeom>
          <a:noFill/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5" name="流程图: 联系 94"/>
          <p:cNvSpPr/>
          <p:nvPr/>
        </p:nvSpPr>
        <p:spPr>
          <a:xfrm>
            <a:off x="5969868" y="1101110"/>
            <a:ext cx="114300" cy="114300"/>
          </a:xfrm>
          <a:prstGeom prst="flowChartConnector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6" name="流程图: 联系 95"/>
          <p:cNvSpPr/>
          <p:nvPr/>
        </p:nvSpPr>
        <p:spPr>
          <a:xfrm>
            <a:off x="5829413" y="992337"/>
            <a:ext cx="114300" cy="114300"/>
          </a:xfrm>
          <a:prstGeom prst="flowChartConnector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7" name="流程图: 联系 96"/>
          <p:cNvSpPr/>
          <p:nvPr/>
        </p:nvSpPr>
        <p:spPr>
          <a:xfrm>
            <a:off x="5969868" y="834146"/>
            <a:ext cx="114300" cy="114300"/>
          </a:xfrm>
          <a:prstGeom prst="flowChartConnector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04" name="直接箭头连接符 103"/>
          <p:cNvCxnSpPr/>
          <p:nvPr/>
        </p:nvCxnSpPr>
        <p:spPr>
          <a:xfrm flipH="1">
            <a:off x="6084168" y="1036387"/>
            <a:ext cx="206525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5" name="TextBox 124"/>
          <p:cNvSpPr txBox="1"/>
          <p:nvPr/>
        </p:nvSpPr>
        <p:spPr>
          <a:xfrm rot="19866963">
            <a:off x="2171412" y="2426059"/>
            <a:ext cx="654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Bcl-2</a:t>
            </a:r>
            <a:endParaRPr lang="zh-CN" altLang="en-US" b="1" dirty="0"/>
          </a:p>
        </p:txBody>
      </p:sp>
      <p:sp>
        <p:nvSpPr>
          <p:cNvPr id="126" name="TextBox 125"/>
          <p:cNvSpPr txBox="1"/>
          <p:nvPr/>
        </p:nvSpPr>
        <p:spPr>
          <a:xfrm>
            <a:off x="3175899" y="2051556"/>
            <a:ext cx="532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 smtClean="0"/>
              <a:t>Bax</a:t>
            </a:r>
            <a:endParaRPr lang="zh-CN" altLang="en-US" b="1" dirty="0"/>
          </a:p>
        </p:txBody>
      </p:sp>
      <p:sp>
        <p:nvSpPr>
          <p:cNvPr id="89" name="流程图: 联系 88"/>
          <p:cNvSpPr/>
          <p:nvPr/>
        </p:nvSpPr>
        <p:spPr>
          <a:xfrm>
            <a:off x="6371579" y="4638720"/>
            <a:ext cx="114300" cy="114300"/>
          </a:xfrm>
          <a:prstGeom prst="flowChartConnector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6552728" y="4499828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b="1" dirty="0"/>
              <a:t>:</a:t>
            </a:r>
            <a:r>
              <a:rPr lang="en-US" altLang="zh-CN" dirty="0"/>
              <a:t>   </a:t>
            </a:r>
            <a:r>
              <a:rPr lang="en-US" altLang="zh-CN" b="1" dirty="0"/>
              <a:t>paracrine factors</a:t>
            </a:r>
            <a:endParaRPr lang="zh-CN" altLang="en-US" b="1" dirty="0"/>
          </a:p>
        </p:txBody>
      </p:sp>
      <p:sp>
        <p:nvSpPr>
          <p:cNvPr id="3" name="TextBox 2"/>
          <p:cNvSpPr txBox="1"/>
          <p:nvPr/>
        </p:nvSpPr>
        <p:spPr>
          <a:xfrm>
            <a:off x="7919894" y="2035065"/>
            <a:ext cx="1164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i="1" dirty="0" smtClean="0"/>
              <a:t>cytoplasm</a:t>
            </a:r>
            <a:endParaRPr lang="zh-CN" altLang="en-US" b="1" i="1" dirty="0"/>
          </a:p>
        </p:txBody>
      </p:sp>
      <p:sp>
        <p:nvSpPr>
          <p:cNvPr id="9" name="TextBox 8"/>
          <p:cNvSpPr txBox="1"/>
          <p:nvPr/>
        </p:nvSpPr>
        <p:spPr>
          <a:xfrm>
            <a:off x="5262290" y="2175653"/>
            <a:ext cx="5767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ROS</a:t>
            </a:r>
            <a:endParaRPr lang="zh-CN" altLang="en-US" b="1" dirty="0"/>
          </a:p>
        </p:txBody>
      </p:sp>
      <p:sp>
        <p:nvSpPr>
          <p:cNvPr id="90" name="TextBox 89"/>
          <p:cNvSpPr txBox="1"/>
          <p:nvPr/>
        </p:nvSpPr>
        <p:spPr>
          <a:xfrm>
            <a:off x="4477931" y="2699628"/>
            <a:ext cx="5767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ROS</a:t>
            </a:r>
            <a:endParaRPr lang="zh-CN" altLang="en-US" b="1" dirty="0"/>
          </a:p>
        </p:txBody>
      </p:sp>
      <p:sp>
        <p:nvSpPr>
          <p:cNvPr id="25" name="流程图: 磁盘 24"/>
          <p:cNvSpPr/>
          <p:nvPr/>
        </p:nvSpPr>
        <p:spPr>
          <a:xfrm>
            <a:off x="6362289" y="3916545"/>
            <a:ext cx="167461" cy="439267"/>
          </a:xfrm>
          <a:prstGeom prst="flowChartMagneticDisk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8" name="流程图: 磁盘 97"/>
          <p:cNvSpPr/>
          <p:nvPr/>
        </p:nvSpPr>
        <p:spPr>
          <a:xfrm>
            <a:off x="3995936" y="1320849"/>
            <a:ext cx="167461" cy="439267"/>
          </a:xfrm>
          <a:prstGeom prst="flowChartMagneticDisk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9" name="矩形 68"/>
          <p:cNvSpPr/>
          <p:nvPr/>
        </p:nvSpPr>
        <p:spPr>
          <a:xfrm>
            <a:off x="107504" y="2060848"/>
            <a:ext cx="72648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solidFill>
                  <a:prstClr val="black"/>
                </a:solidFill>
              </a:rPr>
              <a:t>NPCs </a:t>
            </a:r>
            <a:endParaRPr lang="zh-CN" altLang="en-US" dirty="0"/>
          </a:p>
        </p:txBody>
      </p:sp>
      <p:sp>
        <p:nvSpPr>
          <p:cNvPr id="71" name="矩形 70"/>
          <p:cNvSpPr/>
          <p:nvPr/>
        </p:nvSpPr>
        <p:spPr>
          <a:xfrm>
            <a:off x="6552728" y="3981315"/>
            <a:ext cx="20044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:</a:t>
            </a:r>
            <a:r>
              <a:rPr lang="en-US" altLang="zh-CN" dirty="0" smtClean="0"/>
              <a:t>   </a:t>
            </a:r>
            <a:r>
              <a:rPr lang="en-US" altLang="zh-CN" b="1" dirty="0" err="1" smtClean="0"/>
              <a:t>mechanosensors</a:t>
            </a:r>
            <a:endParaRPr lang="zh-CN" altLang="en-US" b="1" dirty="0"/>
          </a:p>
        </p:txBody>
      </p:sp>
      <p:sp>
        <p:nvSpPr>
          <p:cNvPr id="73" name="TextBox 72"/>
          <p:cNvSpPr txBox="1"/>
          <p:nvPr/>
        </p:nvSpPr>
        <p:spPr>
          <a:xfrm>
            <a:off x="6513151" y="4995735"/>
            <a:ext cx="24099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(</a:t>
            </a:r>
            <a:r>
              <a:rPr lang="en-US" altLang="zh-CN" b="1" dirty="0"/>
              <a:t>Need further </a:t>
            </a:r>
            <a:r>
              <a:rPr lang="en-US" altLang="zh-CN" b="1" dirty="0" smtClean="0"/>
              <a:t>study)</a:t>
            </a:r>
            <a:endParaRPr lang="zh-CN" altLang="en-US" b="1" dirty="0"/>
          </a:p>
        </p:txBody>
      </p:sp>
      <p:cxnSp>
        <p:nvCxnSpPr>
          <p:cNvPr id="77" name="直接连接符 76"/>
          <p:cNvCxnSpPr/>
          <p:nvPr/>
        </p:nvCxnSpPr>
        <p:spPr>
          <a:xfrm>
            <a:off x="4798369" y="1643848"/>
            <a:ext cx="4124780" cy="361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 flipH="1">
            <a:off x="4643493" y="1078312"/>
            <a:ext cx="154876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3" name="直接连接符 52"/>
          <p:cNvCxnSpPr/>
          <p:nvPr/>
        </p:nvCxnSpPr>
        <p:spPr>
          <a:xfrm>
            <a:off x="4644008" y="1760116"/>
            <a:ext cx="0" cy="157093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7" name="直接连接符 66"/>
          <p:cNvCxnSpPr/>
          <p:nvPr/>
        </p:nvCxnSpPr>
        <p:spPr>
          <a:xfrm>
            <a:off x="4572000" y="1935490"/>
            <a:ext cx="160215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0" name="直接连接符 99"/>
          <p:cNvCxnSpPr/>
          <p:nvPr/>
        </p:nvCxnSpPr>
        <p:spPr>
          <a:xfrm flipH="1">
            <a:off x="4834423" y="1079431"/>
            <a:ext cx="154876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1" name="直接连接符 100"/>
          <p:cNvCxnSpPr/>
          <p:nvPr/>
        </p:nvCxnSpPr>
        <p:spPr>
          <a:xfrm flipH="1">
            <a:off x="5271566" y="1079431"/>
            <a:ext cx="154876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3" name="直接连接符 102"/>
          <p:cNvCxnSpPr/>
          <p:nvPr/>
        </p:nvCxnSpPr>
        <p:spPr>
          <a:xfrm flipH="1">
            <a:off x="5054692" y="1079431"/>
            <a:ext cx="154876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5" name="直接连接符 104"/>
          <p:cNvCxnSpPr/>
          <p:nvPr/>
        </p:nvCxnSpPr>
        <p:spPr>
          <a:xfrm flipH="1">
            <a:off x="5509072" y="1078312"/>
            <a:ext cx="154876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7" name="直接连接符 106"/>
          <p:cNvCxnSpPr/>
          <p:nvPr/>
        </p:nvCxnSpPr>
        <p:spPr>
          <a:xfrm>
            <a:off x="4644008" y="1562373"/>
            <a:ext cx="0" cy="157093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8" name="直接连接符 107"/>
          <p:cNvCxnSpPr/>
          <p:nvPr/>
        </p:nvCxnSpPr>
        <p:spPr>
          <a:xfrm>
            <a:off x="4644008" y="1346349"/>
            <a:ext cx="0" cy="157093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9" name="直接连接符 108"/>
          <p:cNvCxnSpPr/>
          <p:nvPr/>
        </p:nvCxnSpPr>
        <p:spPr>
          <a:xfrm>
            <a:off x="4644008" y="1071394"/>
            <a:ext cx="0" cy="157093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3" name="肘形连接符 112"/>
          <p:cNvCxnSpPr/>
          <p:nvPr/>
        </p:nvCxnSpPr>
        <p:spPr>
          <a:xfrm rot="10800000" flipV="1">
            <a:off x="4709465" y="2348880"/>
            <a:ext cx="562101" cy="391398"/>
          </a:xfrm>
          <a:prstGeom prst="bentConnector2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5" name="肘形连接符 114"/>
          <p:cNvCxnSpPr>
            <a:stCxn id="90" idx="3"/>
            <a:endCxn id="9" idx="2"/>
          </p:cNvCxnSpPr>
          <p:nvPr/>
        </p:nvCxnSpPr>
        <p:spPr>
          <a:xfrm flipV="1">
            <a:off x="5054692" y="2544985"/>
            <a:ext cx="495979" cy="339309"/>
          </a:xfrm>
          <a:prstGeom prst="bentConnector2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756035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899592" y="1556792"/>
            <a:ext cx="7776864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S1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diagram of the mechanism and signaling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hway of the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apoptosis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BMSCs on NPCs under compression. Compression loadings enhanced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oduction of ROS,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creased mitochondrial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mbrane potential,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ressed the expression of Bcl-2 and increased the expression of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x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nd the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x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/Bcl-2 complex dissociation led to the release of cytochrome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ytochrome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long with Apaf-1 and caspase-9,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med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ltiprotein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optosome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which ultimately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duced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eaved caspase-9, 3 and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d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the cell apoptosis.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se effects were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ly attenuated by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culturing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MSC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potential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chanosensors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NPCs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paracrin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ctors secreted</a:t>
            </a:r>
            <a:r>
              <a:rPr lang="zh-CN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BMSCs remain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b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lored.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94984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5</TotalTime>
  <Words>153</Words>
  <Application>Microsoft Office PowerPoint</Application>
  <PresentationFormat>全屏显示(4:3)</PresentationFormat>
  <Paragraphs>27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​​</vt:lpstr>
      <vt:lpstr>PowerPoint 演示文稿</vt:lpstr>
      <vt:lpstr>PowerPoint 演示文稿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User</cp:lastModifiedBy>
  <cp:revision>30</cp:revision>
  <dcterms:created xsi:type="dcterms:W3CDTF">2017-10-14T13:37:06Z</dcterms:created>
  <dcterms:modified xsi:type="dcterms:W3CDTF">2017-11-30T08:31:16Z</dcterms:modified>
</cp:coreProperties>
</file>